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6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C651FE-5915-8954-C2AE-403A6342BC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C7F2F3-E14F-2A47-A1F3-214DC56948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71809-962A-4392-79AB-C90726658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124A9E-F38D-7B0B-B120-4135B3EB0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8E42A7-91AD-C0FA-9D35-FFF8DF4CD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749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33FF6-FF38-7820-5BB9-679C64337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1FDF3C-CEAB-4483-3AB8-19E293A3A0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5B8C6-0606-8AB6-293A-CA90ACBCB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D9BB0-4E0E-77A3-DD3E-BD890FA11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F59654-04CB-E4C2-7051-DCE24297F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826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D500DB-BFEA-009B-3A0F-0E20FEE9D5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FC1B3C-FC76-BC35-03F2-3136D3E6BD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B01163-966F-C049-9FC6-CE7D48722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D48B1-7227-FF03-8E95-0CD4F5685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2955DB-79B5-5BDF-8941-E4855A26D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895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A64AB-D3C1-BCE6-D726-2CEA78C41B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128FFF-2444-A29D-3E9C-1EF578EEF9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1D4DD-946A-5009-0846-DB38C1E99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07536A-7536-47F7-C6AC-7D1811CFA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6E98F9-1CD6-118D-EAC8-ACA627E92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54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BC4AB-9D7D-5B8D-829A-7C707D86F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21BF8A-E6E2-9A79-5DF1-7B6828BCB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4AC23E-EEEF-C96C-89A5-493867FB9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3F7C70-E467-109E-6241-56CD73CAC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D7718-7247-29B0-C52E-C32DF60BF2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146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B9D82-7A8A-C73B-CF2C-916E10A16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6CD5BD-42B7-0BF7-0F93-E60C1397CE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05F783-43A2-5D2A-9A28-3D90C612B1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5C9A1B-8406-5CE5-9965-ECCFB967C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79C51F-801A-6E0B-95A1-B3B49180E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D4FB7F-807B-5695-6DAA-B764AF1EC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169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52032-BA79-049D-F413-29DC0DA226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9CA996-C62F-3226-1EA4-2E238F3BB3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A75AB1-D1A6-7386-F516-102C16B3E9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249F8D-3E5F-2554-9F91-D95AB8BCF4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C5E1F8-2F7F-51AC-CB36-66D8991EA6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539BDC-E8B2-5E87-D6B7-B2016DAF4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CFF4D8-2F61-2403-0168-83E9AFC81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0BC2D2-7D9D-7841-5148-EAFD9EE77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151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FD354-2666-C04B-D265-7C8CE4D6F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7CCFBD-956B-F3B5-BA1D-AD4F43848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D5A725-D63C-ABB3-FF48-F7935703D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8705F4-015D-0338-C4F4-D8B9BDFBC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067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2F0F3E-B93B-439D-C605-FC79B469C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B51F03-21DC-5041-9E72-1756EF9CA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C465FC-0229-EED0-06DF-3D40A1BEE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187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AB01A2-0A0A-B6A9-7177-1561CE4E5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E1763B-A8C5-6BF9-C613-2322CF42E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7EB1C0-A4CB-E525-BAC2-BAAF6A3E89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8ECF8-9B8E-B744-8AC5-B80530297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ADC8DC-EEBE-C028-6C81-22582E0BA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CD053B-C911-6426-6389-F40515A7D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47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C8344D-DA25-1BB1-BCE6-09B2F23DA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6BBBAD-EE73-A8E8-898D-4BEC6F0800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B9373E-BEC9-8D5C-9C8B-F9A4DAD2CD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E6F14-05D4-084A-1648-6518C563A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10DFCA-234A-D730-769E-366425B1E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C01B06-EC6F-BBFE-2D95-2B405E230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902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2D63E8-D549-27AA-6B86-DB93196D2A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C340AA-8320-D7BF-98E9-68670CC628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8A5EE-5F40-0F80-5DEF-3F4B6D70B0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DE995-240D-4C58-BC95-D802C0BDF570}" type="datetimeFigureOut">
              <a:rPr lang="en-US" smtClean="0"/>
              <a:t>9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AF91D9-4455-A0C8-DB76-5C0DF7EAAF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A880E-3084-6BA5-9598-D61A9DF564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CD3ED-6DE3-42C2-A66D-810777BC3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671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3DC4AC4-5009-2119-5C58-6D3DDB17003F}"/>
              </a:ext>
            </a:extLst>
          </p:cNvPr>
          <p:cNvSpPr txBox="1"/>
          <p:nvPr/>
        </p:nvSpPr>
        <p:spPr>
          <a:xfrm>
            <a:off x="12357" y="-395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8F200F-14A6-E87F-99CC-B9C722AF0AAF}"/>
              </a:ext>
            </a:extLst>
          </p:cNvPr>
          <p:cNvSpPr txBox="1"/>
          <p:nvPr/>
        </p:nvSpPr>
        <p:spPr>
          <a:xfrm>
            <a:off x="209940" y="551830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5BCB07-7E99-18AD-1B3E-7ED651A20B0C}"/>
              </a:ext>
            </a:extLst>
          </p:cNvPr>
          <p:cNvSpPr txBox="1"/>
          <p:nvPr/>
        </p:nvSpPr>
        <p:spPr>
          <a:xfrm>
            <a:off x="3323739" y="551830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E546170-C3EC-5600-EFB6-FAEB5C6FAB0F}"/>
              </a:ext>
            </a:extLst>
          </p:cNvPr>
          <p:cNvSpPr txBox="1"/>
          <p:nvPr/>
        </p:nvSpPr>
        <p:spPr>
          <a:xfrm>
            <a:off x="7187043" y="551830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0" name="Group 79">
            <a:extLst>
              <a:ext uri="{FF2B5EF4-FFF2-40B4-BE49-F238E27FC236}">
                <a16:creationId xmlns:a16="http://schemas.microsoft.com/office/drawing/2014/main" id="{AEBD06FC-6C92-2E9A-BFAD-854DF1BA6ADA}"/>
              </a:ext>
            </a:extLst>
          </p:cNvPr>
          <p:cNvGrpSpPr/>
          <p:nvPr/>
        </p:nvGrpSpPr>
        <p:grpSpPr>
          <a:xfrm>
            <a:off x="7712436" y="854724"/>
            <a:ext cx="4658783" cy="2000621"/>
            <a:chOff x="5936595" y="705719"/>
            <a:chExt cx="4658783" cy="2000621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B657F5A4-98E0-3F40-F110-B4DE3C1722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49820"/>
            <a:stretch/>
          </p:blipFill>
          <p:spPr>
            <a:xfrm>
              <a:off x="6190201" y="900230"/>
              <a:ext cx="1631077" cy="1644886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9282F7C1-1927-7B46-9838-C072B28DFC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62361"/>
            <a:stretch/>
          </p:blipFill>
          <p:spPr>
            <a:xfrm>
              <a:off x="7802995" y="900230"/>
              <a:ext cx="1631078" cy="1645920"/>
            </a:xfrm>
            <a:prstGeom prst="rect">
              <a:avLst/>
            </a:prstGeom>
          </p:spPr>
        </p:pic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5D8B1A18-FFC9-5B91-4D79-E0A2B1628215}"/>
                </a:ext>
              </a:extLst>
            </p:cNvPr>
            <p:cNvGrpSpPr/>
            <p:nvPr/>
          </p:nvGrpSpPr>
          <p:grpSpPr>
            <a:xfrm>
              <a:off x="9591681" y="1240353"/>
              <a:ext cx="1003697" cy="469525"/>
              <a:chOff x="1813682" y="2727327"/>
              <a:chExt cx="1003697" cy="469525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962875DA-3EA1-D865-28AD-8FB0C4486490}"/>
                  </a:ext>
                </a:extLst>
              </p:cNvPr>
              <p:cNvSpPr txBox="1"/>
              <p:nvPr/>
            </p:nvSpPr>
            <p:spPr>
              <a:xfrm>
                <a:off x="1865909" y="2727327"/>
                <a:ext cx="37803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so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F9FE2E9-E4A6-298D-318E-8F09F86349BB}"/>
                  </a:ext>
                </a:extLst>
              </p:cNvPr>
              <p:cNvSpPr txBox="1"/>
              <p:nvPr/>
            </p:nvSpPr>
            <p:spPr>
              <a:xfrm>
                <a:off x="1865909" y="2935242"/>
                <a:ext cx="9514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mCD33</a:t>
                </a: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C1858123-E9D7-B8C0-3AF8-D9FC7771D169}"/>
                  </a:ext>
                </a:extLst>
              </p:cNvPr>
              <p:cNvSpPr/>
              <p:nvPr/>
            </p:nvSpPr>
            <p:spPr>
              <a:xfrm>
                <a:off x="1813682" y="2812412"/>
                <a:ext cx="91440" cy="91440"/>
              </a:xfrm>
              <a:prstGeom prst="rect">
                <a:avLst/>
              </a:prstGeom>
              <a:solidFill>
                <a:srgbClr val="999999"/>
              </a:solidFill>
              <a:ln>
                <a:solidFill>
                  <a:srgbClr val="3D3D3D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6D8388D8-4F38-7269-1CE9-A478622C80C1}"/>
                  </a:ext>
                </a:extLst>
              </p:cNvPr>
              <p:cNvSpPr/>
              <p:nvPr/>
            </p:nvSpPr>
            <p:spPr>
              <a:xfrm>
                <a:off x="1815009" y="3020327"/>
                <a:ext cx="91440" cy="91440"/>
              </a:xfrm>
              <a:prstGeom prst="rect">
                <a:avLst/>
              </a:prstGeom>
              <a:solidFill>
                <a:srgbClr val="9999FF"/>
              </a:solidFill>
              <a:ln>
                <a:solidFill>
                  <a:srgbClr val="2929FF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3EA1447-3239-7100-6DDB-A9618B622693}"/>
                </a:ext>
              </a:extLst>
            </p:cNvPr>
            <p:cNvSpPr txBox="1"/>
            <p:nvPr/>
          </p:nvSpPr>
          <p:spPr>
            <a:xfrm>
              <a:off x="6865055" y="705719"/>
              <a:ext cx="5550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1498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3F9CA16-B7E2-4933-EEE2-AA7829B815FF}"/>
                </a:ext>
              </a:extLst>
            </p:cNvPr>
            <p:cNvSpPr txBox="1"/>
            <p:nvPr/>
          </p:nvSpPr>
          <p:spPr>
            <a:xfrm>
              <a:off x="8394244" y="705719"/>
              <a:ext cx="7179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LL-AF9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D5D8FC5-9057-9209-7890-058E792571B0}"/>
                </a:ext>
              </a:extLst>
            </p:cNvPr>
            <p:cNvSpPr txBox="1"/>
            <p:nvPr/>
          </p:nvSpPr>
          <p:spPr>
            <a:xfrm rot="16200000">
              <a:off x="5700725" y="1505486"/>
              <a:ext cx="7179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F04A997-C127-A22F-E2AC-627A129B906F}"/>
                </a:ext>
              </a:extLst>
            </p:cNvPr>
            <p:cNvSpPr txBox="1"/>
            <p:nvPr/>
          </p:nvSpPr>
          <p:spPr>
            <a:xfrm>
              <a:off x="6417934" y="2444730"/>
              <a:ext cx="543433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ITC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CE1B4907-777A-1B2C-D066-199FB6E102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03176" y="2574661"/>
              <a:ext cx="813816" cy="1749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A32FDEB-7DEB-F22E-DB7C-ACA6A84AE3C9}"/>
                </a:ext>
              </a:extLst>
            </p:cNvPr>
            <p:cNvSpPr txBox="1"/>
            <p:nvPr/>
          </p:nvSpPr>
          <p:spPr>
            <a:xfrm>
              <a:off x="8033291" y="2444730"/>
              <a:ext cx="67228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V-421</a:t>
              </a:r>
            </a:p>
          </p:txBody>
        </p: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B02DAB49-78EB-4BAD-CD94-825435D245C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55692" y="2574661"/>
              <a:ext cx="731520" cy="1749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476DD7B-22C1-9484-6DCA-DEAAA3E7C5E7}"/>
              </a:ext>
            </a:extLst>
          </p:cNvPr>
          <p:cNvGrpSpPr/>
          <p:nvPr/>
        </p:nvGrpSpPr>
        <p:grpSpPr>
          <a:xfrm>
            <a:off x="719231" y="4422484"/>
            <a:ext cx="2490184" cy="1966594"/>
            <a:chOff x="610989" y="4518956"/>
            <a:chExt cx="2490184" cy="1966594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0A76A771-C27E-D7F6-E006-1B62B1775B7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9546" r="51651" b="5215"/>
            <a:stretch/>
          </p:blipFill>
          <p:spPr>
            <a:xfrm>
              <a:off x="610989" y="4518956"/>
              <a:ext cx="1616319" cy="174650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680689D-0BD5-7FD9-E5A7-79A17B686D84}"/>
                </a:ext>
              </a:extLst>
            </p:cNvPr>
            <p:cNvSpPr txBox="1"/>
            <p:nvPr/>
          </p:nvSpPr>
          <p:spPr>
            <a:xfrm>
              <a:off x="2097931" y="4773434"/>
              <a:ext cx="501138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em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2ABCEE7-BCF8-4ED2-8F82-97445E58D734}"/>
                </a:ext>
              </a:extLst>
            </p:cNvPr>
            <p:cNvSpPr txBox="1"/>
            <p:nvPr/>
          </p:nvSpPr>
          <p:spPr>
            <a:xfrm>
              <a:off x="620027" y="6223940"/>
              <a:ext cx="746267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rotein L</a:t>
              </a:r>
            </a:p>
          </p:txBody>
        </p:sp>
        <p:sp>
          <p:nvSpPr>
            <p:cNvPr id="70" name="Right Bracket 69">
              <a:extLst>
                <a:ext uri="{FF2B5EF4-FFF2-40B4-BE49-F238E27FC236}">
                  <a16:creationId xmlns:a16="http://schemas.microsoft.com/office/drawing/2014/main" id="{324FA9AC-7C5C-E09D-73C6-0792C8BEC0D9}"/>
                </a:ext>
              </a:extLst>
            </p:cNvPr>
            <p:cNvSpPr/>
            <p:nvPr/>
          </p:nvSpPr>
          <p:spPr>
            <a:xfrm>
              <a:off x="2570342" y="5597273"/>
              <a:ext cx="90283" cy="40994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/>
            </a:p>
          </p:txBody>
        </p:sp>
        <p:sp>
          <p:nvSpPr>
            <p:cNvPr id="71" name="Right Bracket 70">
              <a:extLst>
                <a:ext uri="{FF2B5EF4-FFF2-40B4-BE49-F238E27FC236}">
                  <a16:creationId xmlns:a16="http://schemas.microsoft.com/office/drawing/2014/main" id="{CD6E55CD-9CD5-8E64-5344-5945644F086C}"/>
                </a:ext>
              </a:extLst>
            </p:cNvPr>
            <p:cNvSpPr/>
            <p:nvPr/>
          </p:nvSpPr>
          <p:spPr>
            <a:xfrm>
              <a:off x="2572956" y="4848500"/>
              <a:ext cx="90283" cy="56343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CEF2330-60D3-5C0B-8137-C1A068ED84EA}"/>
                </a:ext>
              </a:extLst>
            </p:cNvPr>
            <p:cNvSpPr txBox="1"/>
            <p:nvPr/>
          </p:nvSpPr>
          <p:spPr>
            <a:xfrm rot="16200000">
              <a:off x="2514001" y="4914776"/>
              <a:ext cx="74345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1498-hCD3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893F4F0-DDB5-C9CE-AE46-16E16BF172F0}"/>
                </a:ext>
              </a:extLst>
            </p:cNvPr>
            <p:cNvSpPr txBox="1"/>
            <p:nvPr/>
          </p:nvSpPr>
          <p:spPr>
            <a:xfrm>
              <a:off x="2097931" y="5213098"/>
              <a:ext cx="501138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B1B04309-80E1-9D5E-16C1-B5D8F7126DD1}"/>
                </a:ext>
              </a:extLst>
            </p:cNvPr>
            <p:cNvSpPr txBox="1"/>
            <p:nvPr/>
          </p:nvSpPr>
          <p:spPr>
            <a:xfrm>
              <a:off x="2097931" y="5501949"/>
              <a:ext cx="510330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em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242AA554-8CDA-643D-BF03-2988D8F760AE}"/>
                </a:ext>
              </a:extLst>
            </p:cNvPr>
            <p:cNvSpPr txBox="1"/>
            <p:nvPr/>
          </p:nvSpPr>
          <p:spPr>
            <a:xfrm>
              <a:off x="2097931" y="5790800"/>
              <a:ext cx="501138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15E0B98D-85CC-FBB4-4096-914B4BFA49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64502" y="6353871"/>
              <a:ext cx="731520" cy="1749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0517531-0A4B-C83A-41C7-ACB92CB401C3}"/>
                </a:ext>
              </a:extLst>
            </p:cNvPr>
            <p:cNvSpPr txBox="1"/>
            <p:nvPr/>
          </p:nvSpPr>
          <p:spPr>
            <a:xfrm rot="16200000">
              <a:off x="2425305" y="5671443"/>
              <a:ext cx="7434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</a:p>
          </p:txBody>
        </p: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6C78C1E-AF3D-A72F-3DA9-2C703CEB7CEA}"/>
              </a:ext>
            </a:extLst>
          </p:cNvPr>
          <p:cNvGrpSpPr/>
          <p:nvPr/>
        </p:nvGrpSpPr>
        <p:grpSpPr>
          <a:xfrm>
            <a:off x="3842884" y="812192"/>
            <a:ext cx="3314557" cy="3176523"/>
            <a:chOff x="685425" y="653688"/>
            <a:chExt cx="3314557" cy="3176523"/>
          </a:xfrm>
        </p:grpSpPr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8C9E842C-3238-97B8-DFE4-AE1E8BEB8D6E}"/>
                </a:ext>
              </a:extLst>
            </p:cNvPr>
            <p:cNvCxnSpPr>
              <a:cxnSpLocks/>
            </p:cNvCxnSpPr>
            <p:nvPr/>
          </p:nvCxnSpPr>
          <p:spPr>
            <a:xfrm>
              <a:off x="3405471" y="3700788"/>
              <a:ext cx="459792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E475D28A-FDEA-5FB2-8547-675DDA4D1550}"/>
                </a:ext>
              </a:extLst>
            </p:cNvPr>
            <p:cNvSpPr txBox="1"/>
            <p:nvPr/>
          </p:nvSpPr>
          <p:spPr>
            <a:xfrm rot="16200000">
              <a:off x="335169" y="2880994"/>
              <a:ext cx="962123" cy="26160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uman CD3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1BE388C3-C36F-12B9-B6E9-9315B946ACD1}"/>
                </a:ext>
              </a:extLst>
            </p:cNvPr>
            <p:cNvSpPr txBox="1"/>
            <p:nvPr/>
          </p:nvSpPr>
          <p:spPr>
            <a:xfrm>
              <a:off x="1065055" y="3568601"/>
              <a:ext cx="54694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D33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5BBF5799-1AF6-33A3-E35E-024B4E1DDAE2}"/>
                </a:ext>
              </a:extLst>
            </p:cNvPr>
            <p:cNvSpPr txBox="1"/>
            <p:nvPr/>
          </p:nvSpPr>
          <p:spPr>
            <a:xfrm rot="16200000">
              <a:off x="295895" y="1501267"/>
              <a:ext cx="104067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uman CD19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CD871C8E-B7AA-E637-77D2-2FFD36950BF1}"/>
                </a:ext>
              </a:extLst>
            </p:cNvPr>
            <p:cNvSpPr txBox="1"/>
            <p:nvPr/>
          </p:nvSpPr>
          <p:spPr>
            <a:xfrm>
              <a:off x="2527877" y="3568601"/>
              <a:ext cx="875561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2T-CD33</a:t>
              </a:r>
            </a:p>
          </p:txBody>
        </p:sp>
        <p:cxnSp>
          <p:nvCxnSpPr>
            <p:cNvPr id="114" name="Straight Arrow Connector 113">
              <a:extLst>
                <a:ext uri="{FF2B5EF4-FFF2-40B4-BE49-F238E27FC236}">
                  <a16:creationId xmlns:a16="http://schemas.microsoft.com/office/drawing/2014/main" id="{E6FDB3D4-D478-488D-380A-4A3BA9211743}"/>
                </a:ext>
              </a:extLst>
            </p:cNvPr>
            <p:cNvCxnSpPr>
              <a:cxnSpLocks/>
            </p:cNvCxnSpPr>
            <p:nvPr/>
          </p:nvCxnSpPr>
          <p:spPr>
            <a:xfrm>
              <a:off x="1612000" y="3699406"/>
              <a:ext cx="805910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Arrow Connector 115">
              <a:extLst>
                <a:ext uri="{FF2B5EF4-FFF2-40B4-BE49-F238E27FC236}">
                  <a16:creationId xmlns:a16="http://schemas.microsoft.com/office/drawing/2014/main" id="{46E44043-49D0-3EC0-BC53-07F57C98573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47066" y="959294"/>
              <a:ext cx="338328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8B1B52D2-0C01-70C0-DEDA-EC8B6E49FF5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47066" y="2365183"/>
              <a:ext cx="338328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5793F9E2-8DCE-3747-7112-897D531019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07925" y="653688"/>
              <a:ext cx="3092057" cy="3047100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8AD82601-A15A-E4AE-60F0-F735996DDB42}"/>
              </a:ext>
            </a:extLst>
          </p:cNvPr>
          <p:cNvSpPr txBox="1"/>
          <p:nvPr/>
        </p:nvSpPr>
        <p:spPr>
          <a:xfrm>
            <a:off x="209940" y="4189845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4EFAF427-BFBF-077B-C958-02E5E3F89AFD}"/>
              </a:ext>
            </a:extLst>
          </p:cNvPr>
          <p:cNvGrpSpPr/>
          <p:nvPr/>
        </p:nvGrpSpPr>
        <p:grpSpPr>
          <a:xfrm>
            <a:off x="3411850" y="4432432"/>
            <a:ext cx="2389704" cy="1957090"/>
            <a:chOff x="3458264" y="4498124"/>
            <a:chExt cx="2389704" cy="195709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8977539-E91C-4F55-E3D7-E1458208996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9007" r="51544" b="4840"/>
            <a:stretch/>
          </p:blipFill>
          <p:spPr>
            <a:xfrm>
              <a:off x="3478326" y="4498124"/>
              <a:ext cx="1623556" cy="1746504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AB01058-ED1C-841A-CD9F-FD45D591815C}"/>
                </a:ext>
              </a:extLst>
            </p:cNvPr>
            <p:cNvSpPr txBox="1"/>
            <p:nvPr/>
          </p:nvSpPr>
          <p:spPr>
            <a:xfrm>
              <a:off x="4961107" y="4773100"/>
              <a:ext cx="398205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14268D2-6B0F-F0EF-80A1-3E5AAA08B80E}"/>
                </a:ext>
              </a:extLst>
            </p:cNvPr>
            <p:cNvSpPr txBox="1"/>
            <p:nvPr/>
          </p:nvSpPr>
          <p:spPr>
            <a:xfrm>
              <a:off x="3458264" y="6193604"/>
              <a:ext cx="746267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rotein L</a:t>
              </a:r>
            </a:p>
          </p:txBody>
        </p:sp>
        <p:sp>
          <p:nvSpPr>
            <p:cNvPr id="18" name="Right Bracket 17">
              <a:extLst>
                <a:ext uri="{FF2B5EF4-FFF2-40B4-BE49-F238E27FC236}">
                  <a16:creationId xmlns:a16="http://schemas.microsoft.com/office/drawing/2014/main" id="{B358606A-3621-1F74-832E-0DCB2E9CC08F}"/>
                </a:ext>
              </a:extLst>
            </p:cNvPr>
            <p:cNvSpPr/>
            <p:nvPr/>
          </p:nvSpPr>
          <p:spPr>
            <a:xfrm>
              <a:off x="5317137" y="5558624"/>
              <a:ext cx="90283" cy="40994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/>
            </a:p>
          </p:txBody>
        </p:sp>
        <p:sp>
          <p:nvSpPr>
            <p:cNvPr id="20" name="Right Bracket 19">
              <a:extLst>
                <a:ext uri="{FF2B5EF4-FFF2-40B4-BE49-F238E27FC236}">
                  <a16:creationId xmlns:a16="http://schemas.microsoft.com/office/drawing/2014/main" id="{FE108669-4005-6696-4836-0268DB6A63A1}"/>
                </a:ext>
              </a:extLst>
            </p:cNvPr>
            <p:cNvSpPr/>
            <p:nvPr/>
          </p:nvSpPr>
          <p:spPr>
            <a:xfrm>
              <a:off x="5319751" y="4818164"/>
              <a:ext cx="90283" cy="56343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BE14142-BF91-7A8D-6BCF-7D6839F1EB44}"/>
                </a:ext>
              </a:extLst>
            </p:cNvPr>
            <p:cNvSpPr txBox="1"/>
            <p:nvPr/>
          </p:nvSpPr>
          <p:spPr>
            <a:xfrm rot="16200000">
              <a:off x="5260796" y="4884440"/>
              <a:ext cx="74345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1498-hCD3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6750195-0268-0580-575F-891E58EA33AA}"/>
                </a:ext>
              </a:extLst>
            </p:cNvPr>
            <p:cNvSpPr txBox="1"/>
            <p:nvPr/>
          </p:nvSpPr>
          <p:spPr>
            <a:xfrm>
              <a:off x="4961107" y="5204695"/>
              <a:ext cx="501138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60AC216-706B-A679-93A6-F945743A1079}"/>
                </a:ext>
              </a:extLst>
            </p:cNvPr>
            <p:cNvSpPr txBox="1"/>
            <p:nvPr/>
          </p:nvSpPr>
          <p:spPr>
            <a:xfrm>
              <a:off x="4961107" y="5493857"/>
              <a:ext cx="398205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D3A0D42-3AA2-61CC-3743-A3BCF49D77FD}"/>
                </a:ext>
              </a:extLst>
            </p:cNvPr>
            <p:cNvSpPr txBox="1"/>
            <p:nvPr/>
          </p:nvSpPr>
          <p:spPr>
            <a:xfrm>
              <a:off x="4961107" y="5768164"/>
              <a:ext cx="501138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CA2ADF81-97D9-8012-B359-0141DB19CE6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02739" y="6323535"/>
              <a:ext cx="731520" cy="1749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B567EEF-F3AE-C7F9-CE19-51D87B30A5C3}"/>
                </a:ext>
              </a:extLst>
            </p:cNvPr>
            <p:cNvSpPr txBox="1"/>
            <p:nvPr/>
          </p:nvSpPr>
          <p:spPr>
            <a:xfrm rot="16200000">
              <a:off x="5180413" y="5632794"/>
              <a:ext cx="7434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1498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EFC16766-FF21-E777-0A5B-379AF6CE10A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9780" y="615492"/>
            <a:ext cx="2651760" cy="334608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B229C4B-F634-585A-CF18-78D7D2D7EF65}"/>
              </a:ext>
            </a:extLst>
          </p:cNvPr>
          <p:cNvSpPr txBox="1"/>
          <p:nvPr/>
        </p:nvSpPr>
        <p:spPr>
          <a:xfrm>
            <a:off x="6164681" y="4189845"/>
            <a:ext cx="15075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745E2E4-25AB-B563-C661-8BB9C08C4CA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36018" y="4354437"/>
            <a:ext cx="2723498" cy="2468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5958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a Golick</dc:creator>
  <cp:lastModifiedBy>Lena Golick</cp:lastModifiedBy>
  <cp:revision>2</cp:revision>
  <dcterms:created xsi:type="dcterms:W3CDTF">2025-09-17T18:24:47Z</dcterms:created>
  <dcterms:modified xsi:type="dcterms:W3CDTF">2025-09-17T18:25:11Z</dcterms:modified>
</cp:coreProperties>
</file>